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F0C70-A72F-47FF-9511-1939198873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7533A-AD16-440C-8D82-D06A4DA3A1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752B2-FFB5-4BA9-AE71-8C049AA1BA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2A3079-72DE-49A5-98DC-D76B3D0D22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5A7835-82E1-40DA-AB20-04EBF30AF5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1A3C8-857B-41EA-987A-2EDFCBDB53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4EB16-6675-454C-8A9F-073B030105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E805E6-660D-44B0-9686-FEF7067358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B5853-2305-4579-831A-132449372B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8F0E2-40B5-40AF-B2BE-9BF6C78907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B4809-53B4-4892-A274-C8B23D14B4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9860D-304D-4ECE-A69B-804246F5FF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6A16331-BA55-4708-8E39-336D9773813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9200" y="622440"/>
          <a:ext cx="6637680" cy="3679560"/>
        </p:xfrm>
        <a:graphic>
          <a:graphicData uri="http://schemas.openxmlformats.org/drawingml/2006/table">
            <a:tbl>
              <a:tblPr/>
              <a:tblGrid>
                <a:gridCol w="56880"/>
                <a:gridCol w="696960"/>
                <a:gridCol w="117000"/>
                <a:gridCol w="461520"/>
                <a:gridCol w="208800"/>
                <a:gridCol w="360360"/>
                <a:gridCol w="318960"/>
                <a:gridCol w="312840"/>
                <a:gridCol w="387360"/>
                <a:gridCol w="118800"/>
                <a:gridCol w="505440"/>
                <a:gridCol w="107280"/>
                <a:gridCol w="430200"/>
                <a:gridCol w="301680"/>
                <a:gridCol w="341640"/>
                <a:gridCol w="338040"/>
                <a:gridCol w="366480"/>
                <a:gridCol w="365040"/>
                <a:gridCol w="194400"/>
                <a:gridCol w="537480"/>
                <a:gridCol w="56880"/>
                <a:gridCol w="56880"/>
              </a:tblGrid>
              <a:tr h="3092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oup Statistic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00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mp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Devi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 Me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312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hy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C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6347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4139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7731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92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CA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1363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871378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6163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2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68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948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1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dependent Samples Te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3632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 rowSpan="3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vene's Test for Equality of Varianc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14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test for Equality of Mea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5036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5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% Confidence Interval of the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5912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w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p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5936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 methy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qual variances assum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7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60768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qual variances not assum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0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.3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47520" y="4651200"/>
          <a:ext cx="6588360" cy="4183200"/>
        </p:xfrm>
        <a:graphic>
          <a:graphicData uri="http://schemas.openxmlformats.org/drawingml/2006/table">
            <a:tbl>
              <a:tblPr/>
              <a:tblGrid>
                <a:gridCol w="56880"/>
                <a:gridCol w="718560"/>
                <a:gridCol w="96840"/>
                <a:gridCol w="505080"/>
                <a:gridCol w="166320"/>
                <a:gridCol w="351360"/>
                <a:gridCol w="329040"/>
                <a:gridCol w="219960"/>
                <a:gridCol w="482760"/>
                <a:gridCol w="614160"/>
                <a:gridCol w="118800"/>
                <a:gridCol w="503280"/>
                <a:gridCol w="229320"/>
                <a:gridCol w="457560"/>
                <a:gridCol w="223200"/>
                <a:gridCol w="450720"/>
                <a:gridCol w="281880"/>
                <a:gridCol w="278640"/>
                <a:gridCol w="126720"/>
                <a:gridCol w="56880"/>
                <a:gridCol w="320400"/>
              </a:tblGrid>
              <a:tr h="28440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1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oup Statistic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736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mp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Devi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 Me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40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 methy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C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6347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4139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7731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40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CAx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167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15587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11070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52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0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dependent Samples Te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6656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 rowSpan="3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vene's Test for Equality of Varianc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1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test for Equality of Mea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6836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 row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5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% Confidence Interval of the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52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w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p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7628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hy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qual variances assum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63180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qual variances not assum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0440" marR="1044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84040"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440" rIns="10440" tIns="104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10440" rIns="10440" tIns="104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440" marR="104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3" name="TextBox 5"/>
          <p:cNvSpPr/>
          <p:nvPr/>
        </p:nvSpPr>
        <p:spPr>
          <a:xfrm>
            <a:off x="52560" y="4473720"/>
            <a:ext cx="642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mparison of means of FOXA1 methylation between BRCA1 and BRCA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69840" y="343080"/>
            <a:ext cx="654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mparison of means of FOXA1 methylation between BRCA1 and BRCA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5049000" y="9609120"/>
            <a:ext cx="178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 S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6T23:48:49Z</dcterms:created>
  <dc:creator>Jade Gong</dc:creator>
  <dc:description/>
  <dc:language>en-US</dc:language>
  <cp:lastModifiedBy>Eric Lam</cp:lastModifiedBy>
  <cp:lastPrinted>2014-09-26T09:57:40Z</cp:lastPrinted>
  <dcterms:modified xsi:type="dcterms:W3CDTF">2014-10-01T11:14:24Z</dcterms:modified>
  <cp:revision>591</cp:revision>
  <dc:subject/>
  <dc:title>PowerPoint Presentation</dc:title>
</cp:coreProperties>
</file>